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609" r:id="rId2"/>
    <p:sldId id="610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4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686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 autoAdjust="0"/>
    <p:restoredTop sz="94474" autoAdjust="0"/>
  </p:normalViewPr>
  <p:slideViewPr>
    <p:cSldViewPr snapToGrid="0">
      <p:cViewPr varScale="1">
        <p:scale>
          <a:sx n="51" d="100"/>
          <a:sy n="51" d="100"/>
        </p:scale>
        <p:origin x="2136" y="8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7DC28-9DC6-6E48-8536-3695BBCB729C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BFEA71-BC19-2344-B1DE-8DA16567FAF2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50664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501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8E8D99-2080-444B-A941-58AB31AC8F53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468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5010" y="868468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518817-FCAB-0648-BF8E-59AEA9D0B004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4845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25">
            <a:extLst>
              <a:ext uri="{FF2B5EF4-FFF2-40B4-BE49-F238E27FC236}">
                <a16:creationId xmlns:a16="http://schemas.microsoft.com/office/drawing/2014/main" id="{1DDDF529-3D6E-D542-A43F-54743EE4D386}"/>
              </a:ext>
            </a:extLst>
          </p:cNvPr>
          <p:cNvSpPr txBox="1"/>
          <p:nvPr/>
        </p:nvSpPr>
        <p:spPr>
          <a:xfrm>
            <a:off x="0" y="8774668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Vi et al. S1 Fig</a:t>
            </a:r>
          </a:p>
        </p:txBody>
      </p:sp>
      <p:grpSp>
        <p:nvGrpSpPr>
          <p:cNvPr id="62" name="Group 61"/>
          <p:cNvGrpSpPr/>
          <p:nvPr/>
        </p:nvGrpSpPr>
        <p:grpSpPr>
          <a:xfrm>
            <a:off x="583176" y="308026"/>
            <a:ext cx="2461014" cy="1989443"/>
            <a:chOff x="583176" y="308026"/>
            <a:chExt cx="2461014" cy="1989443"/>
          </a:xfrm>
        </p:grpSpPr>
        <p:pic>
          <p:nvPicPr>
            <p:cNvPr id="11" name="Picture 4">
              <a:extLst>
                <a:ext uri="{FF2B5EF4-FFF2-40B4-BE49-F238E27FC236}">
                  <a16:creationId xmlns:a16="http://schemas.microsoft.com/office/drawing/2014/main" id="{DCE8D4D3-95D9-E64D-93BF-526A38A06DC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3176" y="308026"/>
              <a:ext cx="2461014" cy="19894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7" name="Group 16"/>
            <p:cNvGrpSpPr/>
            <p:nvPr/>
          </p:nvGrpSpPr>
          <p:grpSpPr>
            <a:xfrm>
              <a:off x="1150012" y="1138789"/>
              <a:ext cx="330980" cy="485999"/>
              <a:chOff x="979170" y="2634500"/>
              <a:chExt cx="461010" cy="504940"/>
            </a:xfrm>
          </p:grpSpPr>
          <p:sp>
            <p:nvSpPr>
              <p:cNvPr id="18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012883" y="2634500"/>
                <a:ext cx="411669" cy="239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63" name="Group 62"/>
          <p:cNvGrpSpPr/>
          <p:nvPr/>
        </p:nvGrpSpPr>
        <p:grpSpPr>
          <a:xfrm>
            <a:off x="3699373" y="249944"/>
            <a:ext cx="2266063" cy="2066536"/>
            <a:chOff x="3699373" y="249944"/>
            <a:chExt cx="2266063" cy="2066536"/>
          </a:xfrm>
        </p:grpSpPr>
        <p:pic>
          <p:nvPicPr>
            <p:cNvPr id="12" name="Picture 12">
              <a:extLst>
                <a:ext uri="{FF2B5EF4-FFF2-40B4-BE49-F238E27FC236}">
                  <a16:creationId xmlns:a16="http://schemas.microsoft.com/office/drawing/2014/main" id="{80B4E3AE-9516-954E-8CA6-A509769CB56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99373" y="249944"/>
              <a:ext cx="2266063" cy="20665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フリーフォーム 19">
              <a:extLst>
                <a:ext uri="{FF2B5EF4-FFF2-40B4-BE49-F238E27FC236}">
                  <a16:creationId xmlns:a16="http://schemas.microsoft.com/office/drawing/2014/main" id="{75EE5E4C-92A7-7E45-ABEE-843411717F4C}"/>
                </a:ext>
              </a:extLst>
            </p:cNvPr>
            <p:cNvSpPr/>
            <p:nvPr/>
          </p:nvSpPr>
          <p:spPr>
            <a:xfrm>
              <a:off x="4101710" y="1326934"/>
              <a:ext cx="330980" cy="225861"/>
            </a:xfrm>
            <a:custGeom>
              <a:avLst/>
              <a:gdLst>
                <a:gd name="connsiteX0" fmla="*/ 0 w 641384"/>
                <a:gd name="connsiteY0" fmla="*/ 346388 h 346388"/>
                <a:gd name="connsiteX1" fmla="*/ 0 w 641384"/>
                <a:gd name="connsiteY1" fmla="*/ 0 h 346388"/>
                <a:gd name="connsiteX2" fmla="*/ 641384 w 641384"/>
                <a:gd name="connsiteY2" fmla="*/ 0 h 346388"/>
                <a:gd name="connsiteX3" fmla="*/ 641384 w 641384"/>
                <a:gd name="connsiteY3" fmla="*/ 346388 h 3463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41384" h="346388">
                  <a:moveTo>
                    <a:pt x="0" y="346388"/>
                  </a:moveTo>
                  <a:lnTo>
                    <a:pt x="0" y="0"/>
                  </a:lnTo>
                  <a:lnTo>
                    <a:pt x="641384" y="0"/>
                  </a:lnTo>
                  <a:lnTo>
                    <a:pt x="641384" y="346388"/>
                  </a:lnTo>
                </a:path>
              </a:pathLst>
            </a:cu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25914" y="1066796"/>
              <a:ext cx="295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ns</a:t>
              </a: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501013" y="2290056"/>
            <a:ext cx="1447800" cy="1587500"/>
            <a:chOff x="501013" y="2290056"/>
            <a:chExt cx="1447800" cy="1587500"/>
          </a:xfrm>
        </p:grpSpPr>
        <p:pic>
          <p:nvPicPr>
            <p:cNvPr id="2052" name="Picture 1">
              <a:extLst>
                <a:ext uri="{FF2B5EF4-FFF2-40B4-BE49-F238E27FC236}">
                  <a16:creationId xmlns:a16="http://schemas.microsoft.com/office/drawing/2014/main" id="{8A158939-1732-EE49-8E46-69009542F80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1013" y="2290056"/>
              <a:ext cx="1447800" cy="1587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" name="Group 22"/>
            <p:cNvGrpSpPr/>
            <p:nvPr/>
          </p:nvGrpSpPr>
          <p:grpSpPr>
            <a:xfrm>
              <a:off x="835862" y="2832957"/>
              <a:ext cx="415127" cy="352295"/>
              <a:chOff x="979170" y="2550031"/>
              <a:chExt cx="710725" cy="589409"/>
            </a:xfrm>
          </p:grpSpPr>
          <p:sp>
            <p:nvSpPr>
              <p:cNvPr id="24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65" name="Group 64"/>
          <p:cNvGrpSpPr/>
          <p:nvPr/>
        </p:nvGrpSpPr>
        <p:grpSpPr>
          <a:xfrm>
            <a:off x="1989599" y="2223473"/>
            <a:ext cx="1447800" cy="1658520"/>
            <a:chOff x="1989599" y="2223473"/>
            <a:chExt cx="1447800" cy="1658520"/>
          </a:xfrm>
        </p:grpSpPr>
        <p:pic>
          <p:nvPicPr>
            <p:cNvPr id="2051" name="Picture 2">
              <a:extLst>
                <a:ext uri="{FF2B5EF4-FFF2-40B4-BE49-F238E27FC236}">
                  <a16:creationId xmlns:a16="http://schemas.microsoft.com/office/drawing/2014/main" id="{F9F0121D-9F22-AB40-81D7-C1DEDAD80F3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9599" y="2223473"/>
              <a:ext cx="1447800" cy="16585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9" name="Group 28"/>
            <p:cNvGrpSpPr/>
            <p:nvPr/>
          </p:nvGrpSpPr>
          <p:grpSpPr>
            <a:xfrm>
              <a:off x="2345837" y="2811453"/>
              <a:ext cx="415127" cy="352295"/>
              <a:chOff x="979170" y="2550031"/>
              <a:chExt cx="710725" cy="589409"/>
            </a:xfrm>
          </p:grpSpPr>
          <p:sp>
            <p:nvSpPr>
              <p:cNvPr id="30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66" name="Group 65"/>
          <p:cNvGrpSpPr/>
          <p:nvPr/>
        </p:nvGrpSpPr>
        <p:grpSpPr>
          <a:xfrm>
            <a:off x="3381879" y="2276922"/>
            <a:ext cx="1422400" cy="1562100"/>
            <a:chOff x="3381879" y="2276922"/>
            <a:chExt cx="1422400" cy="1562100"/>
          </a:xfrm>
        </p:grpSpPr>
        <p:pic>
          <p:nvPicPr>
            <p:cNvPr id="2050" name="Picture 3">
              <a:extLst>
                <a:ext uri="{FF2B5EF4-FFF2-40B4-BE49-F238E27FC236}">
                  <a16:creationId xmlns:a16="http://schemas.microsoft.com/office/drawing/2014/main" id="{B1A3C33F-750B-6643-B6C0-FA639071B1A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81879" y="2276922"/>
              <a:ext cx="1422400" cy="156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2" name="Group 31"/>
            <p:cNvGrpSpPr/>
            <p:nvPr/>
          </p:nvGrpSpPr>
          <p:grpSpPr>
            <a:xfrm>
              <a:off x="3720242" y="2906819"/>
              <a:ext cx="415127" cy="352295"/>
              <a:chOff x="979170" y="2550031"/>
              <a:chExt cx="710725" cy="589409"/>
            </a:xfrm>
          </p:grpSpPr>
          <p:sp>
            <p:nvSpPr>
              <p:cNvPr id="33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67" name="Group 66"/>
          <p:cNvGrpSpPr/>
          <p:nvPr/>
        </p:nvGrpSpPr>
        <p:grpSpPr>
          <a:xfrm>
            <a:off x="4809888" y="2260093"/>
            <a:ext cx="1689100" cy="1562100"/>
            <a:chOff x="4809888" y="2260093"/>
            <a:chExt cx="1689100" cy="1562100"/>
          </a:xfrm>
        </p:grpSpPr>
        <p:pic>
          <p:nvPicPr>
            <p:cNvPr id="2049" name="Picture 4">
              <a:extLst>
                <a:ext uri="{FF2B5EF4-FFF2-40B4-BE49-F238E27FC236}">
                  <a16:creationId xmlns:a16="http://schemas.microsoft.com/office/drawing/2014/main" id="{FB63C3AA-F3BB-3143-B3C1-E8FEB2F5D81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09888" y="2260093"/>
              <a:ext cx="1689100" cy="156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5" name="Group 34"/>
            <p:cNvGrpSpPr/>
            <p:nvPr/>
          </p:nvGrpSpPr>
          <p:grpSpPr>
            <a:xfrm>
              <a:off x="5161965" y="2878770"/>
              <a:ext cx="415127" cy="352295"/>
              <a:chOff x="979170" y="2550031"/>
              <a:chExt cx="710725" cy="589409"/>
            </a:xfrm>
          </p:grpSpPr>
          <p:sp>
            <p:nvSpPr>
              <p:cNvPr id="36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6" name="Group 75"/>
          <p:cNvGrpSpPr/>
          <p:nvPr/>
        </p:nvGrpSpPr>
        <p:grpSpPr>
          <a:xfrm>
            <a:off x="503699" y="3876492"/>
            <a:ext cx="1485900" cy="1625600"/>
            <a:chOff x="503699" y="3876492"/>
            <a:chExt cx="1485900" cy="1625600"/>
          </a:xfrm>
        </p:grpSpPr>
        <p:pic>
          <p:nvPicPr>
            <p:cNvPr id="2056" name="Picture 13">
              <a:extLst>
                <a:ext uri="{FF2B5EF4-FFF2-40B4-BE49-F238E27FC236}">
                  <a16:creationId xmlns:a16="http://schemas.microsoft.com/office/drawing/2014/main" id="{2EFD0677-4940-8241-B869-0BE33D02D1B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3699" y="3876492"/>
              <a:ext cx="1485900" cy="1625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8" name="Group 37"/>
            <p:cNvGrpSpPr/>
            <p:nvPr/>
          </p:nvGrpSpPr>
          <p:grpSpPr>
            <a:xfrm>
              <a:off x="876065" y="4522447"/>
              <a:ext cx="415127" cy="352295"/>
              <a:chOff x="979170" y="2550031"/>
              <a:chExt cx="710725" cy="589409"/>
            </a:xfrm>
          </p:grpSpPr>
          <p:sp>
            <p:nvSpPr>
              <p:cNvPr id="39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69" name="Group 68"/>
          <p:cNvGrpSpPr/>
          <p:nvPr/>
        </p:nvGrpSpPr>
        <p:grpSpPr>
          <a:xfrm>
            <a:off x="2017048" y="3876492"/>
            <a:ext cx="1485900" cy="1625600"/>
            <a:chOff x="2017048" y="3876492"/>
            <a:chExt cx="1485900" cy="1625600"/>
          </a:xfrm>
        </p:grpSpPr>
        <p:pic>
          <p:nvPicPr>
            <p:cNvPr id="2055" name="Picture 14">
              <a:extLst>
                <a:ext uri="{FF2B5EF4-FFF2-40B4-BE49-F238E27FC236}">
                  <a16:creationId xmlns:a16="http://schemas.microsoft.com/office/drawing/2014/main" id="{7D9DA82E-2271-AB49-87D2-2FC068273A1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7048" y="3876492"/>
              <a:ext cx="1485900" cy="1625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1" name="Group 40"/>
            <p:cNvGrpSpPr/>
            <p:nvPr/>
          </p:nvGrpSpPr>
          <p:grpSpPr>
            <a:xfrm>
              <a:off x="2401936" y="4539276"/>
              <a:ext cx="415127" cy="352295"/>
              <a:chOff x="979170" y="2550031"/>
              <a:chExt cx="710725" cy="589409"/>
            </a:xfrm>
          </p:grpSpPr>
          <p:sp>
            <p:nvSpPr>
              <p:cNvPr id="42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0" name="Group 69"/>
          <p:cNvGrpSpPr/>
          <p:nvPr/>
        </p:nvGrpSpPr>
        <p:grpSpPr>
          <a:xfrm>
            <a:off x="3371851" y="3876492"/>
            <a:ext cx="1473200" cy="1625600"/>
            <a:chOff x="3371851" y="3876492"/>
            <a:chExt cx="1473200" cy="1625600"/>
          </a:xfrm>
        </p:grpSpPr>
        <p:pic>
          <p:nvPicPr>
            <p:cNvPr id="2054" name="Picture 15">
              <a:extLst>
                <a:ext uri="{FF2B5EF4-FFF2-40B4-BE49-F238E27FC236}">
                  <a16:creationId xmlns:a16="http://schemas.microsoft.com/office/drawing/2014/main" id="{A63CE3E6-2126-8F4D-8A07-2EF7FE1F308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1851" y="3876492"/>
              <a:ext cx="1473200" cy="1625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4" name="Group 43"/>
            <p:cNvGrpSpPr/>
            <p:nvPr/>
          </p:nvGrpSpPr>
          <p:grpSpPr>
            <a:xfrm>
              <a:off x="3742681" y="4528057"/>
              <a:ext cx="415127" cy="352295"/>
              <a:chOff x="979170" y="2550031"/>
              <a:chExt cx="710725" cy="589409"/>
            </a:xfrm>
          </p:grpSpPr>
          <p:sp>
            <p:nvSpPr>
              <p:cNvPr id="45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1" name="Group 70"/>
          <p:cNvGrpSpPr/>
          <p:nvPr/>
        </p:nvGrpSpPr>
        <p:grpSpPr>
          <a:xfrm>
            <a:off x="4845051" y="3914592"/>
            <a:ext cx="1689100" cy="1587500"/>
            <a:chOff x="4845051" y="3914592"/>
            <a:chExt cx="1689100" cy="1587500"/>
          </a:xfrm>
        </p:grpSpPr>
        <p:pic>
          <p:nvPicPr>
            <p:cNvPr id="2053" name="Picture 16">
              <a:extLst>
                <a:ext uri="{FF2B5EF4-FFF2-40B4-BE49-F238E27FC236}">
                  <a16:creationId xmlns:a16="http://schemas.microsoft.com/office/drawing/2014/main" id="{B18306D4-A77C-074B-B118-2DD54107E09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45051" y="3914592"/>
              <a:ext cx="1689100" cy="1587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7" name="Group 46"/>
            <p:cNvGrpSpPr/>
            <p:nvPr/>
          </p:nvGrpSpPr>
          <p:grpSpPr>
            <a:xfrm>
              <a:off x="5184404" y="4556106"/>
              <a:ext cx="415127" cy="352295"/>
              <a:chOff x="979170" y="2550031"/>
              <a:chExt cx="710725" cy="589409"/>
            </a:xfrm>
          </p:grpSpPr>
          <p:sp>
            <p:nvSpPr>
              <p:cNvPr id="48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2" name="Group 71"/>
          <p:cNvGrpSpPr/>
          <p:nvPr/>
        </p:nvGrpSpPr>
        <p:grpSpPr>
          <a:xfrm>
            <a:off x="2077134" y="5635677"/>
            <a:ext cx="1447800" cy="1587500"/>
            <a:chOff x="546285" y="5805201"/>
            <a:chExt cx="1447800" cy="1587500"/>
          </a:xfrm>
        </p:grpSpPr>
        <p:pic>
          <p:nvPicPr>
            <p:cNvPr id="13" name="Picture 18">
              <a:extLst>
                <a:ext uri="{FF2B5EF4-FFF2-40B4-BE49-F238E27FC236}">
                  <a16:creationId xmlns:a16="http://schemas.microsoft.com/office/drawing/2014/main" id="{2D3CB635-7C17-1E4B-B521-994A79309B9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285" y="5805201"/>
              <a:ext cx="1447800" cy="1587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0" name="Group 49"/>
            <p:cNvGrpSpPr/>
            <p:nvPr/>
          </p:nvGrpSpPr>
          <p:grpSpPr>
            <a:xfrm>
              <a:off x="909725" y="6396125"/>
              <a:ext cx="415127" cy="352295"/>
              <a:chOff x="979170" y="2550031"/>
              <a:chExt cx="710725" cy="589409"/>
            </a:xfrm>
          </p:grpSpPr>
          <p:sp>
            <p:nvSpPr>
              <p:cNvPr id="51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3" name="Group 72"/>
          <p:cNvGrpSpPr/>
          <p:nvPr/>
        </p:nvGrpSpPr>
        <p:grpSpPr>
          <a:xfrm>
            <a:off x="626488" y="7213121"/>
            <a:ext cx="1409700" cy="1549400"/>
            <a:chOff x="1998089" y="5831247"/>
            <a:chExt cx="1409700" cy="1549400"/>
          </a:xfrm>
        </p:grpSpPr>
        <p:pic>
          <p:nvPicPr>
            <p:cNvPr id="15" name="Picture 20">
              <a:extLst>
                <a:ext uri="{FF2B5EF4-FFF2-40B4-BE49-F238E27FC236}">
                  <a16:creationId xmlns:a16="http://schemas.microsoft.com/office/drawing/2014/main" id="{F012CB79-E1F6-CD48-B9E2-EE83E23B2EC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8089" y="5831247"/>
              <a:ext cx="1409700" cy="1549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3" name="Group 52"/>
            <p:cNvGrpSpPr/>
            <p:nvPr/>
          </p:nvGrpSpPr>
          <p:grpSpPr>
            <a:xfrm>
              <a:off x="2362667" y="6356857"/>
              <a:ext cx="415127" cy="352295"/>
              <a:chOff x="979170" y="2550031"/>
              <a:chExt cx="710725" cy="589409"/>
            </a:xfrm>
          </p:grpSpPr>
          <p:sp>
            <p:nvSpPr>
              <p:cNvPr id="54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87" name="Group 86"/>
          <p:cNvGrpSpPr/>
          <p:nvPr/>
        </p:nvGrpSpPr>
        <p:grpSpPr>
          <a:xfrm>
            <a:off x="2099124" y="7145676"/>
            <a:ext cx="1501967" cy="1615346"/>
            <a:chOff x="2099125" y="7186222"/>
            <a:chExt cx="1435100" cy="1574800"/>
          </a:xfrm>
        </p:grpSpPr>
        <p:pic>
          <p:nvPicPr>
            <p:cNvPr id="16" name="Picture 21">
              <a:extLst>
                <a:ext uri="{FF2B5EF4-FFF2-40B4-BE49-F238E27FC236}">
                  <a16:creationId xmlns:a16="http://schemas.microsoft.com/office/drawing/2014/main" id="{188E1CE2-79A1-F548-AB50-A3F7399CE1C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9125" y="7186222"/>
              <a:ext cx="1435100" cy="157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6" name="Group 55"/>
            <p:cNvGrpSpPr/>
            <p:nvPr/>
          </p:nvGrpSpPr>
          <p:grpSpPr>
            <a:xfrm>
              <a:off x="2432280" y="7735011"/>
              <a:ext cx="412265" cy="357430"/>
              <a:chOff x="-1663231" y="2893815"/>
              <a:chExt cx="705825" cy="598000"/>
            </a:xfrm>
          </p:grpSpPr>
          <p:sp>
            <p:nvSpPr>
              <p:cNvPr id="57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-1624157" y="3257151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-1663231" y="2893815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5" name="Group 74"/>
          <p:cNvGrpSpPr/>
          <p:nvPr/>
        </p:nvGrpSpPr>
        <p:grpSpPr>
          <a:xfrm>
            <a:off x="3533631" y="5622294"/>
            <a:ext cx="1727200" cy="1600200"/>
            <a:chOff x="4843586" y="5853461"/>
            <a:chExt cx="1727200" cy="1600200"/>
          </a:xfrm>
        </p:grpSpPr>
        <p:pic>
          <p:nvPicPr>
            <p:cNvPr id="14" name="Picture 19">
              <a:extLst>
                <a:ext uri="{FF2B5EF4-FFF2-40B4-BE49-F238E27FC236}">
                  <a16:creationId xmlns:a16="http://schemas.microsoft.com/office/drawing/2014/main" id="{49213F24-39DE-2F49-9D95-EE58C8D9AF0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43586" y="5853461"/>
              <a:ext cx="1727200" cy="16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9" name="Group 58"/>
            <p:cNvGrpSpPr/>
            <p:nvPr/>
          </p:nvGrpSpPr>
          <p:grpSpPr>
            <a:xfrm>
              <a:off x="5184405" y="6424174"/>
              <a:ext cx="415127" cy="352295"/>
              <a:chOff x="979170" y="2550031"/>
              <a:chExt cx="710725" cy="589409"/>
            </a:xfrm>
          </p:grpSpPr>
          <p:sp>
            <p:nvSpPr>
              <p:cNvPr id="60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sp>
        <p:nvSpPr>
          <p:cNvPr id="77" name="TextBox 76"/>
          <p:cNvSpPr txBox="1"/>
          <p:nvPr/>
        </p:nvSpPr>
        <p:spPr>
          <a:xfrm>
            <a:off x="385281" y="159249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3352800" y="151276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388706" y="1965144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78432" y="3655887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grpSp>
        <p:nvGrpSpPr>
          <p:cNvPr id="86" name="Group 85"/>
          <p:cNvGrpSpPr/>
          <p:nvPr/>
        </p:nvGrpSpPr>
        <p:grpSpPr>
          <a:xfrm>
            <a:off x="560739" y="5675116"/>
            <a:ext cx="1447800" cy="1587500"/>
            <a:chOff x="571013" y="5736761"/>
            <a:chExt cx="1447800" cy="1587500"/>
          </a:xfrm>
        </p:grpSpPr>
        <p:pic>
          <p:nvPicPr>
            <p:cNvPr id="82" name="Picture 17">
              <a:extLst>
                <a:ext uri="{FF2B5EF4-FFF2-40B4-BE49-F238E27FC236}">
                  <a16:creationId xmlns:a16="http://schemas.microsoft.com/office/drawing/2014/main" id="{D3B0198F-2440-7045-8B40-19CA7F7A4A4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1013" y="5736761"/>
              <a:ext cx="1447800" cy="1587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3" name="Group 45"/>
            <p:cNvGrpSpPr/>
            <p:nvPr/>
          </p:nvGrpSpPr>
          <p:grpSpPr>
            <a:xfrm>
              <a:off x="919079" y="6384212"/>
              <a:ext cx="412265" cy="362569"/>
              <a:chOff x="-176873" y="2532842"/>
              <a:chExt cx="705825" cy="606598"/>
            </a:xfrm>
          </p:grpSpPr>
          <p:sp>
            <p:nvSpPr>
              <p:cNvPr id="84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-137798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-176873" y="2532842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88" name="Group 87"/>
          <p:cNvGrpSpPr/>
          <p:nvPr/>
        </p:nvGrpSpPr>
        <p:grpSpPr>
          <a:xfrm>
            <a:off x="3504005" y="7145676"/>
            <a:ext cx="1823145" cy="1599036"/>
            <a:chOff x="3344757" y="450327"/>
            <a:chExt cx="1727200" cy="1549400"/>
          </a:xfrm>
        </p:grpSpPr>
        <p:pic>
          <p:nvPicPr>
            <p:cNvPr id="89" name="Picture 22">
              <a:extLst>
                <a:ext uri="{FF2B5EF4-FFF2-40B4-BE49-F238E27FC236}">
                  <a16:creationId xmlns:a16="http://schemas.microsoft.com/office/drawing/2014/main" id="{33A41CBC-DD0D-D549-91BC-EAC0F5109C5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44757" y="450327"/>
              <a:ext cx="1727200" cy="1549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0" name="Group 48"/>
            <p:cNvGrpSpPr/>
            <p:nvPr/>
          </p:nvGrpSpPr>
          <p:grpSpPr>
            <a:xfrm>
              <a:off x="3703412" y="802205"/>
              <a:ext cx="419803" cy="392498"/>
              <a:chOff x="979170" y="2550031"/>
              <a:chExt cx="710725" cy="589409"/>
            </a:xfrm>
          </p:grpSpPr>
          <p:sp>
            <p:nvSpPr>
              <p:cNvPr id="91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sp>
        <p:nvSpPr>
          <p:cNvPr id="93" name="TextBox 92"/>
          <p:cNvSpPr txBox="1"/>
          <p:nvPr/>
        </p:nvSpPr>
        <p:spPr>
          <a:xfrm>
            <a:off x="396624" y="5421329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7636665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25">
            <a:extLst>
              <a:ext uri="{FF2B5EF4-FFF2-40B4-BE49-F238E27FC236}">
                <a16:creationId xmlns:a16="http://schemas.microsoft.com/office/drawing/2014/main" id="{3E10A776-CAB1-134F-88DD-52EDF8D6E715}"/>
              </a:ext>
            </a:extLst>
          </p:cNvPr>
          <p:cNvSpPr txBox="1"/>
          <p:nvPr/>
        </p:nvSpPr>
        <p:spPr>
          <a:xfrm>
            <a:off x="0" y="8774668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Vi et al. S1 Fig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89757" y="4705563"/>
            <a:ext cx="1743663" cy="1919629"/>
            <a:chOff x="89757" y="4705563"/>
            <a:chExt cx="1743663" cy="1919629"/>
          </a:xfrm>
        </p:grpSpPr>
        <p:pic>
          <p:nvPicPr>
            <p:cNvPr id="13" name="Picture 41">
              <a:extLst>
                <a:ext uri="{FF2B5EF4-FFF2-40B4-BE49-F238E27FC236}">
                  <a16:creationId xmlns:a16="http://schemas.microsoft.com/office/drawing/2014/main" id="{AE4F75D9-32B7-034B-AC4E-E5450D9C9B0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757" y="4705563"/>
              <a:ext cx="1743663" cy="191962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7" name="Group 16"/>
            <p:cNvGrpSpPr/>
            <p:nvPr/>
          </p:nvGrpSpPr>
          <p:grpSpPr>
            <a:xfrm>
              <a:off x="551497" y="5469571"/>
              <a:ext cx="334974" cy="403716"/>
              <a:chOff x="1526805" y="1622004"/>
              <a:chExt cx="336737" cy="542260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1528715" y="1622004"/>
                <a:ext cx="33482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ns</a:t>
                </a:r>
              </a:p>
            </p:txBody>
          </p:sp>
          <p:sp>
            <p:nvSpPr>
              <p:cNvPr id="19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1526805" y="1938403"/>
                <a:ext cx="330980" cy="225861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59" name="Group 58"/>
          <p:cNvGrpSpPr/>
          <p:nvPr/>
        </p:nvGrpSpPr>
        <p:grpSpPr>
          <a:xfrm>
            <a:off x="1556522" y="4727982"/>
            <a:ext cx="1740880" cy="1914968"/>
            <a:chOff x="1556522" y="4723749"/>
            <a:chExt cx="1740880" cy="1914968"/>
          </a:xfrm>
        </p:grpSpPr>
        <p:pic>
          <p:nvPicPr>
            <p:cNvPr id="14" name="Picture 42">
              <a:extLst>
                <a:ext uri="{FF2B5EF4-FFF2-40B4-BE49-F238E27FC236}">
                  <a16:creationId xmlns:a16="http://schemas.microsoft.com/office/drawing/2014/main" id="{64D17DF7-3FE3-194E-9C98-78D713CFCE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56522" y="4723749"/>
              <a:ext cx="1740880" cy="19149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1" name="Group 20"/>
            <p:cNvGrpSpPr/>
            <p:nvPr/>
          </p:nvGrpSpPr>
          <p:grpSpPr>
            <a:xfrm>
              <a:off x="1938371" y="5448276"/>
              <a:ext cx="360374" cy="416417"/>
              <a:chOff x="1577872" y="1667492"/>
              <a:chExt cx="362270" cy="559319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1605315" y="1667492"/>
                <a:ext cx="334827" cy="2616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ns</a:t>
                </a:r>
              </a:p>
            </p:txBody>
          </p:sp>
          <p:sp>
            <p:nvSpPr>
              <p:cNvPr id="23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1577872" y="2000950"/>
                <a:ext cx="330980" cy="225861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60" name="Group 59"/>
          <p:cNvGrpSpPr/>
          <p:nvPr/>
        </p:nvGrpSpPr>
        <p:grpSpPr>
          <a:xfrm>
            <a:off x="2960221" y="4642441"/>
            <a:ext cx="1894671" cy="2027630"/>
            <a:chOff x="2960221" y="4642441"/>
            <a:chExt cx="1894671" cy="2027630"/>
          </a:xfrm>
        </p:grpSpPr>
        <p:pic>
          <p:nvPicPr>
            <p:cNvPr id="15" name="Picture 43">
              <a:extLst>
                <a:ext uri="{FF2B5EF4-FFF2-40B4-BE49-F238E27FC236}">
                  <a16:creationId xmlns:a16="http://schemas.microsoft.com/office/drawing/2014/main" id="{DDB63675-4EDB-0C4C-BCEF-5ADAE0E7219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60221" y="4642441"/>
              <a:ext cx="1894671" cy="20276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4" name="Group 23"/>
            <p:cNvGrpSpPr/>
            <p:nvPr/>
          </p:nvGrpSpPr>
          <p:grpSpPr>
            <a:xfrm>
              <a:off x="3491976" y="5588313"/>
              <a:ext cx="334974" cy="403716"/>
              <a:chOff x="1526805" y="1622004"/>
              <a:chExt cx="336737" cy="542260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1528715" y="1622004"/>
                <a:ext cx="33482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ns</a:t>
                </a:r>
              </a:p>
            </p:txBody>
          </p:sp>
          <p:sp>
            <p:nvSpPr>
              <p:cNvPr id="26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1526805" y="1938403"/>
                <a:ext cx="330980" cy="225861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61" name="Group 60"/>
          <p:cNvGrpSpPr/>
          <p:nvPr/>
        </p:nvGrpSpPr>
        <p:grpSpPr>
          <a:xfrm>
            <a:off x="4505287" y="4606746"/>
            <a:ext cx="2352713" cy="2096983"/>
            <a:chOff x="4505287" y="4606746"/>
            <a:chExt cx="2352713" cy="2096983"/>
          </a:xfrm>
        </p:grpSpPr>
        <p:pic>
          <p:nvPicPr>
            <p:cNvPr id="16" name="Picture 44">
              <a:extLst>
                <a:ext uri="{FF2B5EF4-FFF2-40B4-BE49-F238E27FC236}">
                  <a16:creationId xmlns:a16="http://schemas.microsoft.com/office/drawing/2014/main" id="{D13FFFF5-71B4-6A40-A9DB-CDD24634135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05287" y="4606746"/>
              <a:ext cx="2352713" cy="20969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7" name="Group 26"/>
            <p:cNvGrpSpPr/>
            <p:nvPr/>
          </p:nvGrpSpPr>
          <p:grpSpPr>
            <a:xfrm>
              <a:off x="5095445" y="4880539"/>
              <a:ext cx="334857" cy="347616"/>
              <a:chOff x="1526805" y="1697355"/>
              <a:chExt cx="336620" cy="466909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1528718" y="1697355"/>
                <a:ext cx="334707" cy="310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  <p:sp>
            <p:nvSpPr>
              <p:cNvPr id="29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1526805" y="1938403"/>
                <a:ext cx="330980" cy="225861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54" name="Group 53"/>
          <p:cNvGrpSpPr/>
          <p:nvPr/>
        </p:nvGrpSpPr>
        <p:grpSpPr>
          <a:xfrm>
            <a:off x="0" y="2466575"/>
            <a:ext cx="1821116" cy="1994761"/>
            <a:chOff x="0" y="2385603"/>
            <a:chExt cx="1889970" cy="2018103"/>
          </a:xfrm>
        </p:grpSpPr>
        <p:pic>
          <p:nvPicPr>
            <p:cNvPr id="3082" name="Picture 27">
              <a:extLst>
                <a:ext uri="{FF2B5EF4-FFF2-40B4-BE49-F238E27FC236}">
                  <a16:creationId xmlns:a16="http://schemas.microsoft.com/office/drawing/2014/main" id="{0DCC7D45-6E83-3B47-B010-08EFD08B38F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385603"/>
              <a:ext cx="1889970" cy="2018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4" name="Group 33"/>
            <p:cNvGrpSpPr/>
            <p:nvPr/>
          </p:nvGrpSpPr>
          <p:grpSpPr>
            <a:xfrm>
              <a:off x="533866" y="3400484"/>
              <a:ext cx="415127" cy="352295"/>
              <a:chOff x="979170" y="2550031"/>
              <a:chExt cx="710725" cy="589409"/>
            </a:xfrm>
          </p:grpSpPr>
          <p:sp>
            <p:nvSpPr>
              <p:cNvPr id="35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55" name="Group 54"/>
          <p:cNvGrpSpPr/>
          <p:nvPr/>
        </p:nvGrpSpPr>
        <p:grpSpPr>
          <a:xfrm>
            <a:off x="1602764" y="2566468"/>
            <a:ext cx="1678318" cy="1864398"/>
            <a:chOff x="1568186" y="2545535"/>
            <a:chExt cx="1651848" cy="1808489"/>
          </a:xfrm>
        </p:grpSpPr>
        <p:pic>
          <p:nvPicPr>
            <p:cNvPr id="3081" name="Picture 28">
              <a:extLst>
                <a:ext uri="{FF2B5EF4-FFF2-40B4-BE49-F238E27FC236}">
                  <a16:creationId xmlns:a16="http://schemas.microsoft.com/office/drawing/2014/main" id="{58A8901C-3844-DA4E-8E2C-C21EA9CF41A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68186" y="2545535"/>
              <a:ext cx="1651848" cy="180848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7" name="Group 36"/>
            <p:cNvGrpSpPr/>
            <p:nvPr/>
          </p:nvGrpSpPr>
          <p:grpSpPr>
            <a:xfrm>
              <a:off x="1986809" y="3349995"/>
              <a:ext cx="415127" cy="352295"/>
              <a:chOff x="979170" y="2550031"/>
              <a:chExt cx="710725" cy="589409"/>
            </a:xfrm>
          </p:grpSpPr>
          <p:sp>
            <p:nvSpPr>
              <p:cNvPr id="38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56" name="Group 55"/>
          <p:cNvGrpSpPr/>
          <p:nvPr/>
        </p:nvGrpSpPr>
        <p:grpSpPr>
          <a:xfrm>
            <a:off x="3081973" y="2533023"/>
            <a:ext cx="1700960" cy="1876921"/>
            <a:chOff x="2955187" y="2509971"/>
            <a:chExt cx="1700960" cy="1876921"/>
          </a:xfrm>
        </p:grpSpPr>
        <p:pic>
          <p:nvPicPr>
            <p:cNvPr id="3080" name="Picture 29">
              <a:extLst>
                <a:ext uri="{FF2B5EF4-FFF2-40B4-BE49-F238E27FC236}">
                  <a16:creationId xmlns:a16="http://schemas.microsoft.com/office/drawing/2014/main" id="{E02D70B2-BF8E-4A4A-BEAA-987EDCF33DE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55187" y="2509971"/>
              <a:ext cx="1700960" cy="18769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0" name="Group 39"/>
            <p:cNvGrpSpPr/>
            <p:nvPr/>
          </p:nvGrpSpPr>
          <p:grpSpPr>
            <a:xfrm>
              <a:off x="3394872" y="3316337"/>
              <a:ext cx="415127" cy="352295"/>
              <a:chOff x="979170" y="2550031"/>
              <a:chExt cx="710725" cy="589409"/>
            </a:xfrm>
          </p:grpSpPr>
          <p:sp>
            <p:nvSpPr>
              <p:cNvPr id="41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57" name="Group 56"/>
          <p:cNvGrpSpPr/>
          <p:nvPr/>
        </p:nvGrpSpPr>
        <p:grpSpPr>
          <a:xfrm>
            <a:off x="4538341" y="2476072"/>
            <a:ext cx="2319659" cy="1972470"/>
            <a:chOff x="4538341" y="2373917"/>
            <a:chExt cx="2319659" cy="2074625"/>
          </a:xfrm>
        </p:grpSpPr>
        <p:pic>
          <p:nvPicPr>
            <p:cNvPr id="3079" name="Picture 30">
              <a:extLst>
                <a:ext uri="{FF2B5EF4-FFF2-40B4-BE49-F238E27FC236}">
                  <a16:creationId xmlns:a16="http://schemas.microsoft.com/office/drawing/2014/main" id="{E642DF05-A460-574C-8016-22565FE0260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38341" y="2373917"/>
              <a:ext cx="2319659" cy="20746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3" name="Group 42"/>
            <p:cNvGrpSpPr/>
            <p:nvPr/>
          </p:nvGrpSpPr>
          <p:grpSpPr>
            <a:xfrm>
              <a:off x="5111476" y="2828283"/>
              <a:ext cx="415127" cy="352295"/>
              <a:chOff x="979170" y="2550031"/>
              <a:chExt cx="710725" cy="589409"/>
            </a:xfrm>
          </p:grpSpPr>
          <p:sp>
            <p:nvSpPr>
              <p:cNvPr id="44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sp>
        <p:nvSpPr>
          <p:cNvPr id="62" name="TextBox 61"/>
          <p:cNvSpPr txBox="1"/>
          <p:nvPr/>
        </p:nvSpPr>
        <p:spPr>
          <a:xfrm>
            <a:off x="61376" y="1909280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92198" y="4298022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1098077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78</TotalTime>
  <Words>43</Words>
  <Application>Microsoft Office PowerPoint</Application>
  <PresentationFormat>On-screen Show (4:3)</PresentationFormat>
  <Paragraphs>3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テーマ</vt:lpstr>
      <vt:lpstr>PowerPoint Presentation</vt:lpstr>
      <vt:lpstr>PowerPoint Presentation</vt:lpstr>
    </vt:vector>
  </TitlesOfParts>
  <Company>筑波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Arvin Valderrama</dc:creator>
  <cp:lastModifiedBy>chn off32</cp:lastModifiedBy>
  <cp:revision>1030</cp:revision>
  <cp:lastPrinted>2012-10-01T23:38:13Z</cp:lastPrinted>
  <dcterms:created xsi:type="dcterms:W3CDTF">2014-04-21T15:29:02Z</dcterms:created>
  <dcterms:modified xsi:type="dcterms:W3CDTF">2021-05-03T02:59:57Z</dcterms:modified>
</cp:coreProperties>
</file>